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ADC8D6-F9E9-450D-9C4C-BBA761B840A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13BDA-2400-472D-B708-AEE01690B3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A3172-E462-4CA9-9986-4BDA1D68419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27BE1-4161-4B5D-9C06-B421D424AF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25533E-6667-4518-AC72-1210C58BB5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5C0696-BC9A-49D1-BE94-15E8B73A35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EDC8F2-BBD2-4C92-A083-995E85072A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72BC30-97C0-49FD-8B2D-8F97DDEB5B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905FB7-B4A8-4473-99AC-A579539091B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DA6C50-6EFA-481B-9257-6502569083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C7D061-AD7E-4A20-95AE-7A9A1B8851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0C15D9-C98F-49AD-B872-210636806E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AD48692-F2C7-4BB2-8D14-D0A1B470105E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3.png"/><Relationship Id="rId6" Type="http://schemas.openxmlformats.org/officeDocument/2006/relationships/image" Target="../media/image2.png"/><Relationship Id="rId7" Type="http://schemas.openxmlformats.org/officeDocument/2006/relationships/image" Target="../media/image4.png"/><Relationship Id="rId8" Type="http://schemas.openxmlformats.org/officeDocument/2006/relationships/image" Target="../media/image5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782640" y="149400"/>
            <a:ext cx="5029920" cy="2453040"/>
            <a:chOff x="782640" y="149400"/>
            <a:chExt cx="5029920" cy="2453040"/>
          </a:xfrm>
        </p:grpSpPr>
        <p:sp>
          <p:nvSpPr>
            <p:cNvPr id="42" name=""/>
            <p:cNvSpPr/>
            <p:nvPr/>
          </p:nvSpPr>
          <p:spPr>
            <a:xfrm>
              <a:off x="1484280" y="1968840"/>
              <a:ext cx="33807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484280" y="1565280"/>
              <a:ext cx="3380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484280" y="1160640"/>
              <a:ext cx="33807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484280" y="755640"/>
              <a:ext cx="33807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484280" y="351000"/>
              <a:ext cx="33807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484280" y="149400"/>
              <a:ext cx="3380760" cy="2224080"/>
            </a:xfrm>
            <a:prstGeom prst="rect">
              <a:avLst/>
            </a:prstGeom>
            <a:noFill/>
            <a:ln w="936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627200" y="351000"/>
              <a:ext cx="184680" cy="2022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468160" y="351000"/>
              <a:ext cx="186840" cy="2022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320280" y="351000"/>
              <a:ext cx="186840" cy="2022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163400" y="351000"/>
              <a:ext cx="186840" cy="202248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812240" y="636840"/>
              <a:ext cx="186840" cy="173664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655360" y="660600"/>
              <a:ext cx="195840" cy="171288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507120" y="667080"/>
              <a:ext cx="186840" cy="17064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350240" y="642960"/>
              <a:ext cx="184680" cy="173052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999080" y="351000"/>
              <a:ext cx="186840" cy="2022480"/>
            </a:xfrm>
            <a:prstGeom prst="rect">
              <a:avLst/>
            </a:prstGeom>
            <a:solidFill>
              <a:srgbClr val="9933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851560" y="433440"/>
              <a:ext cx="184680" cy="1940040"/>
            </a:xfrm>
            <a:prstGeom prst="rect">
              <a:avLst/>
            </a:prstGeom>
            <a:solidFill>
              <a:srgbClr val="9933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694320" y="363600"/>
              <a:ext cx="184680" cy="2009880"/>
            </a:xfrm>
            <a:prstGeom prst="rect">
              <a:avLst/>
            </a:prstGeom>
            <a:solidFill>
              <a:srgbClr val="9933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535280" y="382680"/>
              <a:ext cx="186840" cy="1990800"/>
            </a:xfrm>
            <a:prstGeom prst="rect">
              <a:avLst/>
            </a:prstGeom>
            <a:solidFill>
              <a:srgbClr val="9933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1715400" y="269640"/>
              <a:ext cx="1440" cy="81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687680" y="270000"/>
              <a:ext cx="6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2558160" y="263160"/>
              <a:ext cx="1440" cy="87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530800" y="263520"/>
              <a:ext cx="6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3410280" y="199800"/>
              <a:ext cx="0" cy="150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382560" y="200160"/>
              <a:ext cx="622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4253040" y="225720"/>
              <a:ext cx="0" cy="12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4225680" y="225720"/>
              <a:ext cx="6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1901880" y="446040"/>
              <a:ext cx="0" cy="190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874520" y="446400"/>
              <a:ext cx="622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2752200" y="579240"/>
              <a:ext cx="1800" cy="81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726640" y="579600"/>
              <a:ext cx="6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3595320" y="528840"/>
              <a:ext cx="1440" cy="138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569400" y="528840"/>
              <a:ext cx="622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4438080" y="490320"/>
              <a:ext cx="180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412520" y="490680"/>
              <a:ext cx="622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2087280" y="225720"/>
              <a:ext cx="1440" cy="125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061360" y="225720"/>
              <a:ext cx="6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2939040" y="350640"/>
              <a:ext cx="1800" cy="82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913840" y="351000"/>
              <a:ext cx="6012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3782160" y="331920"/>
              <a:ext cx="144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754800" y="331920"/>
              <a:ext cx="62280" cy="1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4624920" y="187560"/>
              <a:ext cx="1800" cy="195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4597560" y="187560"/>
              <a:ext cx="622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484280" y="149400"/>
              <a:ext cx="1440" cy="2224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440360" y="2373480"/>
              <a:ext cx="43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440360" y="2171880"/>
              <a:ext cx="43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440360" y="1968840"/>
              <a:ext cx="43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440360" y="1766880"/>
              <a:ext cx="43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440360" y="1565280"/>
              <a:ext cx="43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440360" y="1362240"/>
              <a:ext cx="43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440360" y="1160640"/>
              <a:ext cx="43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440360" y="959040"/>
              <a:ext cx="43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440360" y="755640"/>
              <a:ext cx="439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440360" y="554040"/>
              <a:ext cx="43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1440360" y="351000"/>
              <a:ext cx="43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440360" y="149400"/>
              <a:ext cx="439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422000" y="2373480"/>
              <a:ext cx="62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422000" y="1968840"/>
              <a:ext cx="62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422000" y="1565280"/>
              <a:ext cx="62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422000" y="1160640"/>
              <a:ext cx="62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422000" y="755640"/>
              <a:ext cx="62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422000" y="351000"/>
              <a:ext cx="62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484280" y="2373480"/>
              <a:ext cx="33807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1251360" y="2322720"/>
              <a:ext cx="72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172160" y="19195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1172160" y="15130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172160" y="11098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172160" y="7048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1088640" y="3002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1771920" y="2449800"/>
              <a:ext cx="23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GF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630160" y="2449800"/>
              <a:ext cx="221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RF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416040" y="2449800"/>
              <a:ext cx="30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328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266720" y="2449800"/>
              <a:ext cx="29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328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rot="16200000">
              <a:off x="525600" y="1154880"/>
              <a:ext cx="666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viability (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5024880" y="962280"/>
              <a:ext cx="114840" cy="82440"/>
            </a:xfrm>
            <a:prstGeom prst="rect">
              <a:avLst/>
            </a:prstGeom>
            <a:solidFill>
              <a:srgbClr val="9999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5223600" y="898560"/>
              <a:ext cx="23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no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5024880" y="1254240"/>
              <a:ext cx="114840" cy="81000"/>
            </a:xfrm>
            <a:prstGeom prst="rect">
              <a:avLst/>
            </a:prstGeom>
            <a:solidFill>
              <a:srgbClr val="ff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5228280" y="1217880"/>
              <a:ext cx="584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anti-CD4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5024880" y="1575000"/>
              <a:ext cx="114840" cy="82440"/>
            </a:xfrm>
            <a:prstGeom prst="rect">
              <a:avLst/>
            </a:prstGeom>
            <a:solidFill>
              <a:srgbClr val="993366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5235480" y="1533600"/>
              <a:ext cx="438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CA" sz="1000" spc="-1" strike="noStrike">
                  <a:solidFill>
                    <a:srgbClr val="000000"/>
                  </a:solidFill>
                  <a:latin typeface="????"/>
                  <a:ea typeface="宋体"/>
                </a:rPr>
                <a:t>HA lys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1" name=""/>
          <p:cNvSpPr/>
          <p:nvPr/>
        </p:nvSpPr>
        <p:spPr>
          <a:xfrm>
            <a:off x="725400" y="3917880"/>
            <a:ext cx="40118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5’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GATCT</a:t>
            </a:r>
            <a:r>
              <a:rPr b="1" lang="en-CA" sz="1200" spc="-1" strike="noStrike">
                <a:solidFill>
                  <a:srgbClr val="000000"/>
                </a:solidFill>
                <a:latin typeface="Courier New"/>
                <a:ea typeface="宋体"/>
              </a:rPr>
              <a:t>taactattgttaaccgtgatggc</a:t>
            </a:r>
            <a:r>
              <a:rPr b="0" i="1" lang="en-CA" sz="1200" spc="-1" strike="noStrike">
                <a:solidFill>
                  <a:srgbClr val="000000"/>
                </a:solidFill>
                <a:latin typeface="Courier New"/>
                <a:ea typeface="宋体"/>
              </a:rPr>
              <a:t>atcaagac</a:t>
            </a:r>
            <a:r>
              <a:rPr b="1" lang="en-CA" sz="1200" spc="-1" strike="noStrike">
                <a:solidFill>
                  <a:srgbClr val="000000"/>
                </a:solidFill>
                <a:latin typeface="Courier New"/>
                <a:ea typeface="宋体"/>
              </a:rPr>
              <a:t>gccatcacggttaacaatagtta</a:t>
            </a:r>
            <a:r>
              <a:rPr b="0" i="1" lang="en-CA" sz="1200" spc="-1" strike="noStrike">
                <a:solidFill>
                  <a:srgbClr val="000000"/>
                </a:solidFill>
                <a:latin typeface="Courier New"/>
                <a:ea typeface="宋体"/>
              </a:rPr>
              <a:t>gactgccgaccagcagagcag</a:t>
            </a:r>
            <a:r>
              <a:rPr b="1" lang="en-CA" sz="1200" spc="-1" strike="noStrike">
                <a:solidFill>
                  <a:srgbClr val="000000"/>
                </a:solidFill>
                <a:latin typeface="Courier New"/>
                <a:ea typeface="宋体"/>
              </a:rPr>
              <a:t>tcatagtataacgcttcagcc</a:t>
            </a:r>
            <a:r>
              <a:rPr b="0" i="1" lang="en-CA" sz="1200" spc="-1" strike="noStrike">
                <a:solidFill>
                  <a:srgbClr val="000000"/>
                </a:solidFill>
                <a:latin typeface="Courier New"/>
                <a:ea typeface="宋体"/>
              </a:rPr>
              <a:t>ctttctct</a:t>
            </a:r>
            <a:r>
              <a:rPr b="1" lang="en-CA" sz="1200" spc="-1" strike="noStrike">
                <a:solidFill>
                  <a:srgbClr val="000000"/>
                </a:solidFill>
                <a:latin typeface="Courier New"/>
                <a:ea typeface="宋体"/>
              </a:rPr>
              <a:t>ggctgaagcgttatactatga</a:t>
            </a:r>
            <a:r>
              <a:rPr b="0" i="1" lang="en-US" sz="1200" spc="-1" strike="noStrike">
                <a:solidFill>
                  <a:srgbClr val="000000"/>
                </a:solidFill>
                <a:latin typeface="Courier New"/>
                <a:ea typeface="宋体"/>
              </a:rPr>
              <a:t>ttttt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AAGCTT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宋体"/>
              </a:rPr>
              <a:t>  3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 flipV="1">
            <a:off x="831960" y="3590640"/>
            <a:ext cx="1114200" cy="33948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 flipH="1" flipV="1">
            <a:off x="2701440" y="3608280"/>
            <a:ext cx="1946520" cy="39384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4" name=""/>
          <p:cNvGrpSpPr/>
          <p:nvPr/>
        </p:nvGrpSpPr>
        <p:grpSpPr>
          <a:xfrm>
            <a:off x="615960" y="2779200"/>
            <a:ext cx="4119480" cy="957240"/>
            <a:chOff x="615960" y="2779200"/>
            <a:chExt cx="4119480" cy="957240"/>
          </a:xfrm>
        </p:grpSpPr>
        <p:sp>
          <p:nvSpPr>
            <p:cNvPr id="125" name=""/>
            <p:cNvSpPr/>
            <p:nvPr/>
          </p:nvSpPr>
          <p:spPr>
            <a:xfrm>
              <a:off x="615960" y="3535200"/>
              <a:ext cx="4119480" cy="288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3850560" y="3403440"/>
              <a:ext cx="844200" cy="266400"/>
            </a:xfrm>
            <a:prstGeom prst="rightArrow">
              <a:avLst>
                <a:gd name="adj1" fmla="val 50000"/>
                <a:gd name="adj2" fmla="val 79223"/>
              </a:avLst>
            </a:prstGeom>
            <a:solidFill>
              <a:srgbClr val="99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1378440" y="3384360"/>
              <a:ext cx="175320" cy="291960"/>
            </a:xfrm>
            <a:prstGeom prst="rightArrow">
              <a:avLst>
                <a:gd name="adj1" fmla="val 50000"/>
                <a:gd name="adj2" fmla="val 25000"/>
              </a:avLst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748440" y="3454200"/>
              <a:ext cx="761400" cy="154080"/>
            </a:xfrm>
            <a:prstGeom prst="rect">
              <a:avLst/>
            </a:prstGeom>
            <a:blipFill rotWithShape="0">
              <a:blip r:embed="rId1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742760" y="3470040"/>
              <a:ext cx="946440" cy="1382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 rot="2234400">
              <a:off x="4248720" y="3323520"/>
              <a:ext cx="96120" cy="426960"/>
            </a:xfrm>
            <a:custGeom>
              <a:avLst/>
              <a:gdLst/>
              <a:ahLst/>
              <a:rect l="l" t="t" r="r" b="b"/>
              <a:pathLst>
                <a:path w="144" h="240">
                  <a:moveTo>
                    <a:pt x="96" y="0"/>
                  </a:moveTo>
                  <a:lnTo>
                    <a:pt x="0" y="144"/>
                  </a:lnTo>
                  <a:lnTo>
                    <a:pt x="144" y="96"/>
                  </a:lnTo>
                  <a:lnTo>
                    <a:pt x="48" y="240"/>
                  </a:lnTo>
                </a:path>
              </a:pathLst>
            </a:custGeom>
            <a:blipFill rotWithShape="0">
              <a:blip r:embed="rId2"/>
              <a:srcRect/>
              <a:tile tx="0" ty="0" sx="100000" sy="100000" algn="ctr"/>
            </a:blipFill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968200" y="3087360"/>
              <a:ext cx="39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F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rot="18474600">
              <a:off x="1840320" y="3038400"/>
              <a:ext cx="7628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siRNA-CD4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rot="18474600">
              <a:off x="691200" y="3066120"/>
              <a:ext cx="74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H1 promot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723960" y="3382560"/>
              <a:ext cx="0" cy="142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rot="16200000">
              <a:off x="514080" y="3081600"/>
              <a:ext cx="43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Narrow"/>
                  <a:ea typeface="宋体"/>
                </a:rPr>
                <a:t>BamH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rot="16128000">
              <a:off x="1572480" y="3165120"/>
              <a:ext cx="3484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Narrow"/>
                  <a:ea typeface="宋体"/>
                </a:rPr>
                <a:t>Bgl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rot="16138800">
              <a:off x="2494440" y="3124080"/>
              <a:ext cx="423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 Narrow"/>
                  <a:ea typeface="宋体"/>
                </a:rPr>
                <a:t>HindIII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718280" y="3384360"/>
              <a:ext cx="0" cy="142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2709000" y="3377880"/>
              <a:ext cx="0" cy="141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rot="2234400">
              <a:off x="1083600" y="3303000"/>
              <a:ext cx="95040" cy="426960"/>
            </a:xfrm>
            <a:custGeom>
              <a:avLst/>
              <a:gdLst/>
              <a:ahLst/>
              <a:rect l="l" t="t" r="r" b="b"/>
              <a:pathLst>
                <a:path w="144" h="240">
                  <a:moveTo>
                    <a:pt x="96" y="0"/>
                  </a:moveTo>
                  <a:lnTo>
                    <a:pt x="0" y="144"/>
                  </a:lnTo>
                  <a:lnTo>
                    <a:pt x="144" y="96"/>
                  </a:lnTo>
                  <a:lnTo>
                    <a:pt x="48" y="240"/>
                  </a:lnTo>
                </a:path>
              </a:pathLst>
            </a:custGeom>
            <a:blipFill rotWithShape="0">
              <a:blip r:embed="rId3"/>
              <a:srcRect/>
              <a:tile tx="0" ty="0" sx="100000" sy="100000" algn="ctr"/>
            </a:blipFill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3522960" y="3403440"/>
              <a:ext cx="175320" cy="266400"/>
            </a:xfrm>
            <a:prstGeom prst="rightArrow">
              <a:avLst>
                <a:gd name="adj1" fmla="val 50000"/>
                <a:gd name="adj2" fmla="val 25000"/>
              </a:avLst>
            </a:prstGeom>
            <a:blipFill rotWithShape="0">
              <a:blip r:embed="rId4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2886840" y="3466800"/>
              <a:ext cx="765360" cy="141480"/>
            </a:xfrm>
            <a:prstGeom prst="rect">
              <a:avLst/>
            </a:prstGeom>
            <a:blipFill rotWithShape="0">
              <a:blip r:embed="rId5"/>
              <a:srcRect/>
              <a:tile tx="0" ty="0" sx="100000" sy="100000" algn="ctr"/>
            </a:blip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rot="2234400">
              <a:off x="3153600" y="3323520"/>
              <a:ext cx="95040" cy="426960"/>
            </a:xfrm>
            <a:custGeom>
              <a:avLst/>
              <a:gdLst/>
              <a:ahLst/>
              <a:rect l="l" t="t" r="r" b="b"/>
              <a:pathLst>
                <a:path w="144" h="240">
                  <a:moveTo>
                    <a:pt x="96" y="0"/>
                  </a:moveTo>
                  <a:lnTo>
                    <a:pt x="0" y="144"/>
                  </a:lnTo>
                  <a:lnTo>
                    <a:pt x="144" y="96"/>
                  </a:lnTo>
                  <a:lnTo>
                    <a:pt x="48" y="240"/>
                  </a:lnTo>
                </a:path>
              </a:pathLst>
            </a:custGeom>
            <a:blipFill rotWithShape="0">
              <a:blip r:embed="rId6"/>
              <a:srcRect/>
              <a:tile tx="0" ty="0" sx="100000" sy="100000" algn="ctr"/>
            </a:blipFill>
            <a:ln w="284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995280" y="3085920"/>
              <a:ext cx="6181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eomyc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45" name="" descr=""/>
          <p:cNvPicPr/>
          <p:nvPr/>
        </p:nvPicPr>
        <p:blipFill>
          <a:blip r:embed="rId7"/>
          <a:stretch/>
        </p:blipFill>
        <p:spPr>
          <a:xfrm>
            <a:off x="4975200" y="3727440"/>
            <a:ext cx="1222560" cy="773280"/>
          </a:xfrm>
          <a:prstGeom prst="rect">
            <a:avLst/>
          </a:prstGeom>
          <a:ln w="0">
            <a:noFill/>
          </a:ln>
        </p:spPr>
      </p:pic>
      <p:sp>
        <p:nvSpPr>
          <p:cNvPr id="146" name=""/>
          <p:cNvSpPr/>
          <p:nvPr/>
        </p:nvSpPr>
        <p:spPr>
          <a:xfrm rot="18336000">
            <a:off x="5156280" y="3407400"/>
            <a:ext cx="3801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 rot="18339000">
            <a:off x="5711400" y="3284280"/>
            <a:ext cx="7246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siRNA-CD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6163200" y="39481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CD4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82520" y="14940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64880" y="29512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1" name=""/>
          <p:cNvGrpSpPr/>
          <p:nvPr/>
        </p:nvGrpSpPr>
        <p:grpSpPr>
          <a:xfrm>
            <a:off x="785880" y="5033880"/>
            <a:ext cx="3672000" cy="2851200"/>
            <a:chOff x="785880" y="5033880"/>
            <a:chExt cx="3672000" cy="2851200"/>
          </a:xfrm>
        </p:grpSpPr>
        <p:pic>
          <p:nvPicPr>
            <p:cNvPr id="152" name="" descr=""/>
            <p:cNvPicPr/>
            <p:nvPr/>
          </p:nvPicPr>
          <p:blipFill>
            <a:blip r:embed="rId8"/>
            <a:stretch/>
          </p:blipFill>
          <p:spPr>
            <a:xfrm>
              <a:off x="785880" y="5033880"/>
              <a:ext cx="3672000" cy="2851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3" name=""/>
            <p:cNvSpPr/>
            <p:nvPr/>
          </p:nvSpPr>
          <p:spPr>
            <a:xfrm rot="3451200">
              <a:off x="1321920" y="5716080"/>
              <a:ext cx="177840" cy="228240"/>
            </a:xfrm>
            <a:custGeom>
              <a:avLst/>
              <a:gdLst>
                <a:gd name="textAreaLeft" fmla="*/ 113760 w 177840"/>
                <a:gd name="textAreaRight" fmla="*/ 177840 w 177840"/>
                <a:gd name="textAreaTop" fmla="*/ 5760 h 228240"/>
                <a:gd name="textAreaBottom" fmla="*/ 222480 h 2282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rot="14587200">
              <a:off x="1870920" y="6708960"/>
              <a:ext cx="177480" cy="276120"/>
            </a:xfrm>
            <a:custGeom>
              <a:avLst/>
              <a:gdLst>
                <a:gd name="textAreaLeft" fmla="*/ 113400 w 177480"/>
                <a:gd name="textAreaRight" fmla="*/ 177840 w 177480"/>
                <a:gd name="textAreaTop" fmla="*/ 7200 h 276120"/>
                <a:gd name="textAreaBottom" fmla="*/ 268920 h 2761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5" name=""/>
          <p:cNvSpPr/>
          <p:nvPr/>
        </p:nvSpPr>
        <p:spPr>
          <a:xfrm>
            <a:off x="164880" y="49640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宋体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08T15:43:37Z</dcterms:created>
  <dc:creator>B. Yang</dc:creator>
  <dc:description/>
  <dc:language>en-US</dc:language>
  <cp:lastModifiedBy>B. Yang</cp:lastModifiedBy>
  <dcterms:modified xsi:type="dcterms:W3CDTF">2008-05-08T15:49:10Z</dcterms:modified>
  <cp:revision>1</cp:revision>
  <dc:subject/>
  <dc:title>Slide 1</dc:title>
</cp:coreProperties>
</file>